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312" r:id="rId2"/>
    <p:sldId id="323" r:id="rId3"/>
    <p:sldId id="321" r:id="rId4"/>
    <p:sldId id="317" r:id="rId5"/>
  </p:sldIdLst>
  <p:sldSz cx="6858000" cy="9144000" type="screen4x3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yoti Kajla" initials="JK" lastIdx="3" clrIdx="0"/>
  <p:cmAuthor id="1" name="Ron Qu" initials="RQ" lastIdx="3" clrIdx="1"/>
  <p:cmAuthor id="2" name="Heike Inge Winter Sederoff" initials="HIWS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D74C41"/>
    <a:srgbClr val="C75951"/>
    <a:srgbClr val="B12F25"/>
    <a:srgbClr val="E6665C"/>
    <a:srgbClr val="800000"/>
    <a:srgbClr val="C6605E"/>
    <a:srgbClr val="FFFFFF"/>
    <a:srgbClr val="EC716E"/>
    <a:srgbClr val="A793BF"/>
    <a:srgbClr val="EB6663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86" autoAdjust="0"/>
    <p:restoredTop sz="96914" autoAdjust="0"/>
  </p:normalViewPr>
  <p:slideViewPr>
    <p:cSldViewPr>
      <p:cViewPr varScale="1">
        <p:scale>
          <a:sx n="57" d="100"/>
          <a:sy n="57" d="100"/>
        </p:scale>
        <p:origin x="-2400" y="-8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fjyoti\Documents\paper%20graphs\chlorophyll%20extracts%205.1.14-1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fjyoti\Documents\Lab%20Records%202012\Feb%202014\Licor%20results%20Feb%207%20201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style val="5"/>
  <c:chart>
    <c:plotArea>
      <c:layout>
        <c:manualLayout>
          <c:layoutTarget val="inner"/>
          <c:xMode val="edge"/>
          <c:yMode val="edge"/>
          <c:x val="0.12373122845875405"/>
          <c:y val="0.10866068059918818"/>
          <c:w val="0.83411528696623194"/>
          <c:h val="0.75875348613225591"/>
        </c:manualLayout>
      </c:layout>
      <c:barChart>
        <c:barDir val="col"/>
        <c:grouping val="clustered"/>
        <c:ser>
          <c:idx val="0"/>
          <c:order val="0"/>
          <c:spPr>
            <a:solidFill>
              <a:schemeClr val="bg1">
                <a:lumMod val="50000"/>
              </a:schemeClr>
            </a:solidFill>
          </c:spPr>
          <c:errBars>
            <c:errBarType val="both"/>
            <c:errValType val="cust"/>
            <c:plus>
              <c:numRef>
                <c:f>Sheet2!$M$37:$M$41</c:f>
                <c:numCache>
                  <c:formatCode>General</c:formatCode>
                  <c:ptCount val="5"/>
                  <c:pt idx="0">
                    <c:v>2.594069837586863E-2</c:v>
                  </c:pt>
                  <c:pt idx="1">
                    <c:v>0.13837427255337845</c:v>
                  </c:pt>
                  <c:pt idx="2">
                    <c:v>7.8945542118204134E-2</c:v>
                  </c:pt>
                  <c:pt idx="3">
                    <c:v>0.16696594129670922</c:v>
                  </c:pt>
                  <c:pt idx="4">
                    <c:v>0.16239022083790636</c:v>
                  </c:pt>
                </c:numCache>
              </c:numRef>
            </c:plus>
            <c:minus>
              <c:numRef>
                <c:f>Sheet2!$M$37:$M$41</c:f>
                <c:numCache>
                  <c:formatCode>General</c:formatCode>
                  <c:ptCount val="5"/>
                  <c:pt idx="0">
                    <c:v>2.594069837586863E-2</c:v>
                  </c:pt>
                  <c:pt idx="1">
                    <c:v>0.13837427255337845</c:v>
                  </c:pt>
                  <c:pt idx="2">
                    <c:v>7.8945542118204134E-2</c:v>
                  </c:pt>
                  <c:pt idx="3">
                    <c:v>0.16696594129670922</c:v>
                  </c:pt>
                  <c:pt idx="4">
                    <c:v>0.16239022083790636</c:v>
                  </c:pt>
                </c:numCache>
              </c:numRef>
            </c:minus>
          </c:errBars>
          <c:cat>
            <c:strRef>
              <c:f>Sheet2!$K$37:$K$41</c:f>
              <c:strCache>
                <c:ptCount val="5"/>
                <c:pt idx="0">
                  <c:v>WT</c:v>
                </c:pt>
                <c:pt idx="1">
                  <c:v>DEF2 (60)</c:v>
                </c:pt>
                <c:pt idx="2">
                  <c:v>DEF2 (72)</c:v>
                </c:pt>
                <c:pt idx="3">
                  <c:v>DEF2+TG1 (51)</c:v>
                </c:pt>
                <c:pt idx="4">
                  <c:v>DEF2+TG1 (69)</c:v>
                </c:pt>
              </c:strCache>
            </c:strRef>
          </c:cat>
          <c:val>
            <c:numRef>
              <c:f>Sheet2!$L$37:$L$41</c:f>
              <c:numCache>
                <c:formatCode>General</c:formatCode>
                <c:ptCount val="5"/>
                <c:pt idx="0">
                  <c:v>1.0550280138542674</c:v>
                </c:pt>
                <c:pt idx="1">
                  <c:v>1.0755225250990146</c:v>
                </c:pt>
                <c:pt idx="2">
                  <c:v>1.042406384971267</c:v>
                </c:pt>
                <c:pt idx="3">
                  <c:v>1.1820244844685561</c:v>
                </c:pt>
                <c:pt idx="4">
                  <c:v>1.2342728680288622</c:v>
                </c:pt>
              </c:numCache>
            </c:numRef>
          </c:val>
        </c:ser>
        <c:dLbls/>
        <c:axId val="81440128"/>
        <c:axId val="82834560"/>
      </c:barChart>
      <c:catAx>
        <c:axId val="81440128"/>
        <c:scaling>
          <c:orientation val="minMax"/>
        </c:scaling>
        <c:axPos val="b"/>
        <c:numFmt formatCode="General" sourceLinked="0"/>
        <c:tickLblPos val="nextTo"/>
        <c:crossAx val="82834560"/>
        <c:crosses val="autoZero"/>
        <c:auto val="1"/>
        <c:lblAlgn val="ctr"/>
        <c:lblOffset val="100"/>
      </c:catAx>
      <c:valAx>
        <c:axId val="82834560"/>
        <c:scaling>
          <c:orientation val="minMax"/>
        </c:scaling>
        <c:axPos val="l"/>
        <c:numFmt formatCode="General" sourceLinked="1"/>
        <c:tickLblPos val="nextTo"/>
        <c:crossAx val="81440128"/>
        <c:crosses val="autoZero"/>
        <c:crossBetween val="between"/>
      </c:valAx>
    </c:plotArea>
    <c:plotVisOnly val="1"/>
    <c:dispBlanksAs val="gap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IN"/>
  <c:chart>
    <c:autoTitleDeleted val="1"/>
    <c:plotArea>
      <c:layout>
        <c:manualLayout>
          <c:layoutTarget val="inner"/>
          <c:xMode val="edge"/>
          <c:yMode val="edge"/>
          <c:x val="0.21912673415823025"/>
          <c:y val="0.14744648844565411"/>
          <c:w val="0.76940944881889772"/>
          <c:h val="0.49926740775050182"/>
        </c:manualLayout>
      </c:layout>
      <c:barChart>
        <c:barDir val="col"/>
        <c:grouping val="clustered"/>
        <c:ser>
          <c:idx val="0"/>
          <c:order val="0"/>
          <c:tx>
            <c:strRef>
              <c:f>Sheet1!$I$133</c:f>
              <c:strCache>
                <c:ptCount val="1"/>
                <c:pt idx="0">
                  <c:v>Fv/Fm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</c:spPr>
          <c:errBars>
            <c:errBarType val="both"/>
            <c:errValType val="cust"/>
            <c:plus>
              <c:numRef>
                <c:f>Sheet1!$J$134:$J$141</c:f>
                <c:numCache>
                  <c:formatCode>General</c:formatCode>
                  <c:ptCount val="8"/>
                  <c:pt idx="0">
                    <c:v>1.5849905463296284E-2</c:v>
                  </c:pt>
                  <c:pt idx="1">
                    <c:v>1.2083158035288125E-2</c:v>
                  </c:pt>
                  <c:pt idx="2">
                    <c:v>1.030228142141313E-2</c:v>
                  </c:pt>
                  <c:pt idx="3">
                    <c:v>8.380428006181162E-3</c:v>
                  </c:pt>
                  <c:pt idx="4">
                    <c:v>1.2714742665000122E-2</c:v>
                  </c:pt>
                  <c:pt idx="5">
                    <c:v>3.0352491814239122E-3</c:v>
                  </c:pt>
                  <c:pt idx="6">
                    <c:v>1.0537399062500509E-2</c:v>
                  </c:pt>
                  <c:pt idx="7">
                    <c:v>1.014618279647635E-2</c:v>
                  </c:pt>
                </c:numCache>
              </c:numRef>
            </c:plus>
            <c:minus>
              <c:numRef>
                <c:f>Sheet1!$J$134:$J$141</c:f>
                <c:numCache>
                  <c:formatCode>General</c:formatCode>
                  <c:ptCount val="8"/>
                  <c:pt idx="0">
                    <c:v>1.5849905463296284E-2</c:v>
                  </c:pt>
                  <c:pt idx="1">
                    <c:v>1.2083158035288125E-2</c:v>
                  </c:pt>
                  <c:pt idx="2">
                    <c:v>1.030228142141313E-2</c:v>
                  </c:pt>
                  <c:pt idx="3">
                    <c:v>8.380428006181162E-3</c:v>
                  </c:pt>
                  <c:pt idx="4">
                    <c:v>1.2714742665000122E-2</c:v>
                  </c:pt>
                  <c:pt idx="5">
                    <c:v>3.0352491814239122E-3</c:v>
                  </c:pt>
                  <c:pt idx="6">
                    <c:v>1.0537399062500509E-2</c:v>
                  </c:pt>
                  <c:pt idx="7">
                    <c:v>1.014618279647635E-2</c:v>
                  </c:pt>
                </c:numCache>
              </c:numRef>
            </c:minus>
          </c:errBars>
          <c:cat>
            <c:strRef>
              <c:f>Sheet1!$H$134:$H$138</c:f>
              <c:strCache>
                <c:ptCount val="5"/>
                <c:pt idx="0">
                  <c:v>WT</c:v>
                </c:pt>
                <c:pt idx="1">
                  <c:v>DEF2(60)</c:v>
                </c:pt>
                <c:pt idx="2">
                  <c:v>DEF2(72)</c:v>
                </c:pt>
                <c:pt idx="3">
                  <c:v>DEF2+TG1(51)</c:v>
                </c:pt>
                <c:pt idx="4">
                  <c:v>DEF2+TG1(69)</c:v>
                </c:pt>
              </c:strCache>
            </c:strRef>
          </c:cat>
          <c:val>
            <c:numRef>
              <c:f>Sheet1!$I$134:$I$138</c:f>
              <c:numCache>
                <c:formatCode>General</c:formatCode>
                <c:ptCount val="5"/>
                <c:pt idx="0">
                  <c:v>0.84952351572664075</c:v>
                </c:pt>
                <c:pt idx="1">
                  <c:v>0.8507215456030105</c:v>
                </c:pt>
                <c:pt idx="2">
                  <c:v>0.85245769911675817</c:v>
                </c:pt>
                <c:pt idx="3">
                  <c:v>0.84791479218827548</c:v>
                </c:pt>
                <c:pt idx="4">
                  <c:v>0.85090100000000013</c:v>
                </c:pt>
              </c:numCache>
            </c:numRef>
          </c:val>
        </c:ser>
        <c:dLbls/>
        <c:axId val="83306752"/>
        <c:axId val="83332096"/>
      </c:barChart>
      <c:catAx>
        <c:axId val="83306752"/>
        <c:scaling>
          <c:orientation val="minMax"/>
        </c:scaling>
        <c:axPos val="b"/>
        <c:numFmt formatCode="General" sourceLinked="0"/>
        <c:tickLblPos val="nextTo"/>
        <c:crossAx val="83332096"/>
        <c:crosses val="autoZero"/>
        <c:auto val="1"/>
        <c:lblAlgn val="ctr"/>
        <c:lblOffset val="100"/>
      </c:catAx>
      <c:valAx>
        <c:axId val="83332096"/>
        <c:scaling>
          <c:orientation val="minMax"/>
        </c:scaling>
        <c:axPos val="l"/>
        <c:numFmt formatCode="General" sourceLinked="1"/>
        <c:tickLblPos val="nextTo"/>
        <c:crossAx val="83306752"/>
        <c:crosses val="autoZero"/>
        <c:crossBetween val="between"/>
        <c:minorUnit val="1.0000000000000004E-2"/>
      </c:valAx>
    </c:plotArea>
    <c:plotVisOnly val="1"/>
    <c:dispBlanksAs val="gap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0924</cdr:x>
      <cdr:y>0.06119</cdr:y>
    </cdr:from>
    <cdr:to>
      <cdr:x>0.0554</cdr:x>
      <cdr:y>0.81043</cdr:y>
    </cdr:to>
    <cdr:sp macro="" textlink="">
      <cdr:nvSpPr>
        <cdr:cNvPr id="2" name="TextBox 4"/>
        <cdr:cNvSpPr txBox="1"/>
      </cdr:nvSpPr>
      <cdr:spPr>
        <a:xfrm xmlns:a="http://schemas.openxmlformats.org/drawingml/2006/main" rot="16200000">
          <a:off x="-749908" y="954696"/>
          <a:ext cx="1866198" cy="261606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 b="0" dirty="0">
              <a:latin typeface="Times New Roman" panose="02020603050405020304" pitchFamily="18" charset="0"/>
              <a:cs typeface="Times New Roman" panose="02020603050405020304" pitchFamily="18" charset="0"/>
            </a:rPr>
            <a:t>Concentration</a:t>
          </a:r>
          <a:r>
            <a:rPr lang="en-US" sz="1100" b="0" baseline="0" dirty="0">
              <a:latin typeface="Times New Roman" panose="02020603050405020304" pitchFamily="18" charset="0"/>
              <a:cs typeface="Times New Roman" panose="02020603050405020304" pitchFamily="18" charset="0"/>
            </a:rPr>
            <a:t> in leaf (mg/mL</a:t>
          </a:r>
          <a:endParaRPr lang="en-US" sz="1100" b="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1236</cdr:x>
      <cdr:y>0.05969</cdr:y>
    </cdr:from>
    <cdr:to>
      <cdr:x>0.1573</cdr:x>
      <cdr:y>0.68192</cdr:y>
    </cdr:to>
    <cdr:sp macro="" textlink="">
      <cdr:nvSpPr>
        <cdr:cNvPr id="2" name="TextBox 1"/>
        <cdr:cNvSpPr txBox="1"/>
      </cdr:nvSpPr>
      <cdr:spPr>
        <a:xfrm xmlns:a="http://schemas.openxmlformats.org/drawingml/2006/main" rot="16200000">
          <a:off x="108363" y="808269"/>
          <a:ext cx="1612074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100" dirty="0"/>
            <a:t>Fv/</a:t>
          </a:r>
          <a:r>
            <a:rPr lang="en-US" sz="1100" dirty="0" err="1"/>
            <a:t>Fm</a:t>
          </a:r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A3825F-91D7-464F-BABC-8142FE378D4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0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A8D944-38C3-45C9-AE50-717F64B8771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49727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933453453"/>
              </p:ext>
            </p:extLst>
          </p:nvPr>
        </p:nvGraphicFramePr>
        <p:xfrm>
          <a:off x="709612" y="609600"/>
          <a:ext cx="5667375" cy="2490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7" name="Rectangle 36"/>
          <p:cNvSpPr/>
          <p:nvPr/>
        </p:nvSpPr>
        <p:spPr>
          <a:xfrm>
            <a:off x="457200" y="3200400"/>
            <a:ext cx="6096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Chlorophyll content of bypass transgenics. The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hyll content per leaf fresh weight was measured. Overall, bypass transgenics had comparable amount of chlorophyll to WT per mg. leaf tissue. </a:t>
            </a: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675907054"/>
              </p:ext>
            </p:extLst>
          </p:nvPr>
        </p:nvGraphicFramePr>
        <p:xfrm>
          <a:off x="152400" y="4876800"/>
          <a:ext cx="6324600" cy="2590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Rectangle 10"/>
          <p:cNvSpPr/>
          <p:nvPr/>
        </p:nvSpPr>
        <p:spPr>
          <a:xfrm>
            <a:off x="381000" y="7685782"/>
            <a:ext cx="617220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v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m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atios of bypass transgenics. Chlorophyll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(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v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m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measured using LI6400-XT on dark-acclimated plants. Based on the ratios, the maximum efficiency of photosystem II was estimated to be comparable between bypass transgenics and WT. </a:t>
            </a:r>
          </a:p>
        </p:txBody>
      </p:sp>
    </p:spTree>
    <p:extLst>
      <p:ext uri="{BB962C8B-B14F-4D97-AF65-F5344CB8AC3E}">
        <p14:creationId xmlns:p14="http://schemas.microsoft.com/office/powerpoint/2010/main" xmlns="" val="1632045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736205863"/>
              </p:ext>
            </p:extLst>
          </p:nvPr>
        </p:nvGraphicFramePr>
        <p:xfrm>
          <a:off x="1066800" y="533400"/>
          <a:ext cx="5029198" cy="171450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945473"/>
                <a:gridCol w="816745"/>
                <a:gridCol w="816745"/>
                <a:gridCol w="816745"/>
                <a:gridCol w="816745"/>
                <a:gridCol w="816745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nt Lin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ount of transgenic protein (µg/g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cD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c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c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2(60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±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±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±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2(72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±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±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±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2+TG1(51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±0.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±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±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±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±1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2+TG1(69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±0.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±0.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±0.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±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±0.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1(10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1±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±0.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1(29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±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4±3.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±0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381000" y="7779603"/>
            <a:ext cx="64008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 area of different transgenic lines (measured using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J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287347139"/>
              </p:ext>
            </p:extLst>
          </p:nvPr>
        </p:nvGraphicFramePr>
        <p:xfrm>
          <a:off x="1473199" y="4125337"/>
          <a:ext cx="4546601" cy="3436620"/>
        </p:xfrm>
        <a:graphic>
          <a:graphicData uri="http://schemas.openxmlformats.org/drawingml/2006/table">
            <a:tbl>
              <a:tblPr/>
              <a:tblGrid>
                <a:gridCol w="839373"/>
                <a:gridCol w="739973"/>
                <a:gridCol w="706840"/>
                <a:gridCol w="739973"/>
                <a:gridCol w="780469"/>
                <a:gridCol w="739973"/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 gridSpan="6">
                  <a:txBody>
                    <a:bodyPr/>
                    <a:lstStyle/>
                    <a:p>
                      <a:pPr algn="ctr" rtl="0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eaf area (cm</a:t>
                      </a:r>
                      <a:r>
                        <a:rPr lang="en-US" sz="11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8100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trols       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m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2 li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m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2+TG1 li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cm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-5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-4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-5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-5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-4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-5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-5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-4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-5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-5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-4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-4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-58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-4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-5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-58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-4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-5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-58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-4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-5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71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-48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-5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8100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G contro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G DEF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G DEF2+TG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228600" y="2514600"/>
            <a:ext cx="64008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transgenic protein content in various lines was determined using peptide-specific antibodies by ELISA. </a:t>
            </a:r>
          </a:p>
        </p:txBody>
      </p:sp>
    </p:spTree>
    <p:extLst>
      <p:ext uri="{BB962C8B-B14F-4D97-AF65-F5344CB8AC3E}">
        <p14:creationId xmlns:p14="http://schemas.microsoft.com/office/powerpoint/2010/main" xmlns="" val="255179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41223" y="526130"/>
            <a:ext cx="2953218" cy="2866042"/>
            <a:chOff x="1462415" y="4425018"/>
            <a:chExt cx="2953218" cy="2866042"/>
          </a:xfrm>
        </p:grpSpPr>
        <p:pic>
          <p:nvPicPr>
            <p:cNvPr id="3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099" t="8538" r="4171" b="5940"/>
            <a:stretch/>
          </p:blipFill>
          <p:spPr bwMode="auto">
            <a:xfrm>
              <a:off x="1724024" y="4607867"/>
              <a:ext cx="2691609" cy="24787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4" name="Group 3"/>
            <p:cNvGrpSpPr/>
            <p:nvPr/>
          </p:nvGrpSpPr>
          <p:grpSpPr>
            <a:xfrm>
              <a:off x="1462415" y="4425018"/>
              <a:ext cx="2481676" cy="2866042"/>
              <a:chOff x="1462415" y="4425018"/>
              <a:chExt cx="2481676" cy="2866042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2311913" y="4425018"/>
                <a:ext cx="16321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otSmear</a:t>
                </a:r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DEF2 vs. WT</a:t>
                </a:r>
                <a:endPara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 rot="16200000">
                <a:off x="1039222" y="5751225"/>
                <a:ext cx="11079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 fold change</a:t>
                </a:r>
                <a:endPara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2520304" y="7029450"/>
                <a:ext cx="121539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g concentration</a:t>
                </a:r>
                <a:endPara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8" name="Group 7"/>
          <p:cNvGrpSpPr/>
          <p:nvPr/>
        </p:nvGrpSpPr>
        <p:grpSpPr>
          <a:xfrm>
            <a:off x="3601025" y="595193"/>
            <a:ext cx="2905120" cy="2775898"/>
            <a:chOff x="3571880" y="4410075"/>
            <a:chExt cx="2905120" cy="2775898"/>
          </a:xfrm>
        </p:grpSpPr>
        <p:pic>
          <p:nvPicPr>
            <p:cNvPr id="9" name="Picture 6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468" t="8091" r="3011" b="4731"/>
            <a:stretch/>
          </p:blipFill>
          <p:spPr bwMode="auto">
            <a:xfrm>
              <a:off x="3810000" y="4617392"/>
              <a:ext cx="2667000" cy="24787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4414129" y="4410075"/>
              <a:ext cx="19720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otSmear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DEF2+TG1 vs. WT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3148687" y="5588988"/>
              <a:ext cx="1107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 fold change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629769" y="6924363"/>
              <a:ext cx="121539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 concentration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635932" y="3919179"/>
            <a:ext cx="2808671" cy="2553860"/>
            <a:chOff x="142876" y="4089188"/>
            <a:chExt cx="2808671" cy="2553860"/>
          </a:xfrm>
        </p:grpSpPr>
        <p:pic>
          <p:nvPicPr>
            <p:cNvPr id="14" name="Picture 7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522" t="10238" r="5228" b="8754"/>
            <a:stretch/>
          </p:blipFill>
          <p:spPr bwMode="auto">
            <a:xfrm>
              <a:off x="391097" y="4357062"/>
              <a:ext cx="2560450" cy="21434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745511" y="4089188"/>
              <a:ext cx="21259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otSmear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DEF2 +TG1 vs. DEF2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-280317" y="5103213"/>
              <a:ext cx="1107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 fold change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200765" y="6381438"/>
              <a:ext cx="121539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 concentration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Rectangle 20"/>
          <p:cNvSpPr/>
          <p:nvPr/>
        </p:nvSpPr>
        <p:spPr>
          <a:xfrm>
            <a:off x="537742" y="6781800"/>
            <a:ext cx="5968403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c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Smear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ots were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ed using the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geR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ckage. A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otSmear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is used to visualize the relationship between the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unt concentrations and fold change in a log scale. In the figure, red dots represent differentially expressed genes between the samples. The orange dots represent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zero count values in some of the samples. The blue line  represents biological significance at 2 log-FC.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57200" y="15240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7200" y="3424535"/>
            <a:ext cx="3209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58473" y="152400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9683746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8600" y="304800"/>
            <a:ext cx="5067300" cy="84023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sequence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</a:p>
          <a:p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hXho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5’-TGGAGAAACTCGAGCTTGTCGATCGACCTTGTACAGCTCGTCCAT-3’ </a:t>
            </a:r>
          </a:p>
          <a:p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ChXhoR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5’-TAAAGCATGGTTCTCGAGCTTTCGCAGATATGGTGAGCAAGGGC-3’.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CS-F1 5’-CCACTATGGTCGCTCCTTTC-3’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CCP-F1 5’-TTCTCTCCAAGCCTAGTCGC-3’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CD-R2: 5’-CTGCAAGTCCAGCTTTTTCC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CE-R2: 5’-AAGTTCCCTTGCAGCTTTCA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CF-R2: 5’- TCCTTAACGAATGCACCACA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CL-R2:5’- GAAACAGGCTTTGCGATAGC-3’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R-R2: 5’- TTTTCCGAGGAGTTCGAAGA-3’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P1 FP 5’- </a:t>
            </a:r>
            <a:r>
              <a:rPr lang="en-US" sz="1200" cap="al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gcccgaatgagtaaagaa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3’ 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P1 RP 5’</a:t>
            </a:r>
            <a:r>
              <a:rPr lang="en-US" sz="1200" cap="all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sz="1200" cap="all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gcttgttctcatccat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-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’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RNA-seq validation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87597_c0_seq1 (Chloroplastic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etylcoenzym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carboxylase 1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’-GATGCCGATGACA A ACA AGA-3’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 5’-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TCAGA A AGCCACA A ACACA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105151_c0_seq8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ioredox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perfamily protein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ACAAGAGTGGTCGGGAGATA-3’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GGTCTGTACCGTTTGGTAGTG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102484_c0_seq2 (Cytidin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oxycytidyla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amina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mily protein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CAACCATCCCAATCACAACTCT -3’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TCCTCGATCAATCCACGAACT 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108897_c0_seq7 (mitochondrial import inner membran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locas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unit tim17 tim22 tim23 family protein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GCCATCCTTGAACTGCTTCTC -3’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5’-CTCCGTGAGCTTCTCTTCACTA 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91143_c0_seq1 (AT3G28918 very small protein coding gene with unknown function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TGCTCTTTCGAGTTTGAGTT-3’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AAAGAGGGAAGCTAAAGCC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99717_c0_seq4 (Cytochrome b-c1 subunit 8 protein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GTCTCGTACTCGTACTGTGGAA -3’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5’- CGCAAGCCTAGTGTTTGTAGTT-3’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108897_c0_seq4 (Putative Protein )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GGTGCATCCTTAGTGAAGAGAA-3’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 </a:t>
            </a:r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AAGTTCGGAACGAGGCTAAC-3</a:t>
            </a:r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’</a:t>
            </a:r>
          </a:p>
          <a:p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gen sequences:</a:t>
            </a:r>
          </a:p>
          <a:p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cD </a:t>
            </a:r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LDGALPDVDRTSC</a:t>
            </a:r>
          </a:p>
          <a:p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cE GLAGPRRPWSGSVRC</a:t>
            </a:r>
          </a:p>
          <a:p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cF </a:t>
            </a:r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PAETVKAKPRPPL</a:t>
            </a:r>
          </a:p>
          <a:p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L </a:t>
            </a:r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HTGSVEKYTEGRK</a:t>
            </a:r>
          </a:p>
          <a:p>
            <a:r>
              <a:rPr lang="pt-B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R  </a:t>
            </a:r>
            <a:r>
              <a:rPr lang="pt-B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VSGGEIGAREGT</a:t>
            </a:r>
          </a:p>
          <a:p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76828" y="8534400"/>
            <a:ext cx="624459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6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and antigen sequences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879048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2</TotalTime>
  <Words>600</Words>
  <Application>Microsoft Office PowerPoint</Application>
  <PresentationFormat>On-screen Show (4:3)</PresentationFormat>
  <Paragraphs>160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yoti Kajla</dc:creator>
  <cp:lastModifiedBy>0010194</cp:lastModifiedBy>
  <cp:revision>535</cp:revision>
  <cp:lastPrinted>2015-04-06T20:47:27Z</cp:lastPrinted>
  <dcterms:created xsi:type="dcterms:W3CDTF">2006-08-16T00:00:00Z</dcterms:created>
  <dcterms:modified xsi:type="dcterms:W3CDTF">2015-10-19T06:47:31Z</dcterms:modified>
</cp:coreProperties>
</file>